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48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828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99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776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548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56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194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027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630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236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698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84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86041-E1BC-471F-BE2D-EC0D2716E29C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1CBBE-5CB6-46E7-9848-2363335C0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881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96">
            <a:extLst>
              <a:ext uri="{FF2B5EF4-FFF2-40B4-BE49-F238E27FC236}">
                <a16:creationId xmlns="" xmlns:a16="http://schemas.microsoft.com/office/drawing/2014/main" id="{CFE14AB9-0B50-4F8E-868C-D7664389B5D1}"/>
              </a:ext>
            </a:extLst>
          </p:cNvPr>
          <p:cNvSpPr txBox="1"/>
          <p:nvPr/>
        </p:nvSpPr>
        <p:spPr>
          <a:xfrm>
            <a:off x="574175" y="7501571"/>
            <a:ext cx="5511605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</a:t>
            </a:r>
            <a:r>
              <a:rPr lang="zh-CN" alt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3 </a:t>
            </a:r>
            <a:r>
              <a:rPr lang="en-US" altLang="zh-CN" sz="900" b="1" dirty="0" err="1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Heatmap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of negative 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gulation </a:t>
            </a:r>
            <a:r>
              <a:rPr lang="en-US" altLang="zh-CN" sz="900" b="1" dirty="0" err="1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bscisic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cid activity signaling pathway. </a:t>
            </a:r>
            <a:r>
              <a:rPr lang="en-US" altLang="zh-CN" sz="900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K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, 02, 04 and 08 represent 0, 2, 4 and 8 hours of salt treatment, respectively. 1A, 2A and 3A represent three biological replicates</a:t>
            </a:r>
            <a:r>
              <a:rPr lang="en-US" altLang="zh-CN" sz="900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</a:t>
            </a:r>
            <a:endParaRPr lang="en-US" altLang="zh-CN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grpSp>
        <p:nvGrpSpPr>
          <p:cNvPr id="7" name="组合 4">
            <a:extLst>
              <a:ext uri="{FF2B5EF4-FFF2-40B4-BE49-F238E27FC236}">
                <a16:creationId xmlns="" xmlns:a16="http://schemas.microsoft.com/office/drawing/2014/main" id="{799BCD77-989E-4814-BDBE-2F1435EF7810}"/>
              </a:ext>
            </a:extLst>
          </p:cNvPr>
          <p:cNvGrpSpPr/>
          <p:nvPr/>
        </p:nvGrpSpPr>
        <p:grpSpPr>
          <a:xfrm>
            <a:off x="574175" y="230535"/>
            <a:ext cx="5390488" cy="7271036"/>
            <a:chOff x="148123" y="-2139079"/>
            <a:chExt cx="7037767" cy="8309239"/>
          </a:xfrm>
        </p:grpSpPr>
        <p:grpSp>
          <p:nvGrpSpPr>
            <p:cNvPr id="8" name="组合 5">
              <a:extLst>
                <a:ext uri="{FF2B5EF4-FFF2-40B4-BE49-F238E27FC236}">
                  <a16:creationId xmlns="" xmlns:a16="http://schemas.microsoft.com/office/drawing/2014/main" id="{7C918388-459A-4ECB-8D76-D3556C012D8C}"/>
                </a:ext>
              </a:extLst>
            </p:cNvPr>
            <p:cNvGrpSpPr/>
            <p:nvPr/>
          </p:nvGrpSpPr>
          <p:grpSpPr>
            <a:xfrm>
              <a:off x="148123" y="-2139079"/>
              <a:ext cx="7037767" cy="7780951"/>
              <a:chOff x="-5474016" y="-11609"/>
              <a:chExt cx="10346507" cy="7780951"/>
            </a:xfrm>
          </p:grpSpPr>
          <p:pic>
            <p:nvPicPr>
              <p:cNvPr id="10" name="Picture 4">
                <a:extLst>
                  <a:ext uri="{FF2B5EF4-FFF2-40B4-BE49-F238E27FC236}">
                    <a16:creationId xmlns="" xmlns:a16="http://schemas.microsoft.com/office/drawing/2014/main" id="{0DEE8FAD-0A7B-43C3-83C9-A81BE11A2C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33" r="11171" b="5641"/>
              <a:stretch/>
            </p:blipFill>
            <p:spPr>
              <a:xfrm>
                <a:off x="-5474016" y="130393"/>
                <a:ext cx="8794452" cy="7430400"/>
              </a:xfrm>
              <a:prstGeom prst="rect">
                <a:avLst/>
              </a:prstGeom>
            </p:spPr>
          </p:pic>
          <p:sp>
            <p:nvSpPr>
              <p:cNvPr id="11" name="文本框 8">
                <a:extLst>
                  <a:ext uri="{FF2B5EF4-FFF2-40B4-BE49-F238E27FC236}">
                    <a16:creationId xmlns="" xmlns:a16="http://schemas.microsoft.com/office/drawing/2014/main" id="{ECFA71C6-C116-49D3-8269-9063F35ACFA1}"/>
                  </a:ext>
                </a:extLst>
              </p:cNvPr>
              <p:cNvSpPr txBox="1"/>
              <p:nvPr/>
            </p:nvSpPr>
            <p:spPr>
              <a:xfrm>
                <a:off x="3230338" y="62217"/>
                <a:ext cx="1557809" cy="77071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088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4G008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111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200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1G229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061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042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6G153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300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1G006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135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7G043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3G087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7G262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4G175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193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253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3G292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228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3G151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201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4G080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0G066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20G1379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8G321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1G241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6G213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8G281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9G049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6G259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1G008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028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7G214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3G084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6G260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4G058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3G125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059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3G113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012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9G049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8G211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9G053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6G268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6G137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230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245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7G149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272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3G025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6G142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4G222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7G187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091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7G149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6G040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0G142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302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3G090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8G056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222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3G225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8G035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6G179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250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6G076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040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8G177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7G015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250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256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4G188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0G145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5G0039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20G094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6G286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7G1043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4G205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8G070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122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2G015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5G189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0141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0G0129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20G1506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0G2438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4G2497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6G1380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8G158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1G1275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20G0179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2G0932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4G2314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19G120900 </a:t>
                </a:r>
              </a:p>
              <a:p>
                <a:pPr>
                  <a:lnSpc>
                    <a:spcPct val="85000"/>
                  </a:lnSpc>
                </a:pPr>
                <a:r>
                  <a:rPr lang="en-US" altLang="zh-CN" sz="529" dirty="0">
                    <a:latin typeface="Arial" panose="020B0604020202020204" pitchFamily="34" charset="0"/>
                    <a:cs typeface="Arial" panose="020B0604020202020204" pitchFamily="34" charset="0"/>
                  </a:rPr>
                  <a:t>Glyma.09G190600</a:t>
                </a:r>
                <a:endParaRPr lang="zh-CN" altLang="en-US" sz="52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" name="Picture 4">
                <a:extLst>
                  <a:ext uri="{FF2B5EF4-FFF2-40B4-BE49-F238E27FC236}">
                    <a16:creationId xmlns="" xmlns:a16="http://schemas.microsoft.com/office/drawing/2014/main" id="{44F76F6D-E4C1-4D92-BEFB-EC756AC603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257"/>
              <a:stretch/>
            </p:blipFill>
            <p:spPr>
              <a:xfrm>
                <a:off x="4564828" y="-11609"/>
                <a:ext cx="307663" cy="7230838"/>
              </a:xfrm>
              <a:prstGeom prst="rect">
                <a:avLst/>
              </a:prstGeom>
            </p:spPr>
          </p:pic>
        </p:grpSp>
        <p:sp>
          <p:nvSpPr>
            <p:cNvPr id="9" name="文本框 6">
              <a:extLst>
                <a:ext uri="{FF2B5EF4-FFF2-40B4-BE49-F238E27FC236}">
                  <a16:creationId xmlns="" xmlns:a16="http://schemas.microsoft.com/office/drawing/2014/main" id="{22B0F7FF-1058-4DC6-818E-49162B983262}"/>
                </a:ext>
              </a:extLst>
            </p:cNvPr>
            <p:cNvSpPr txBox="1"/>
            <p:nvPr/>
          </p:nvSpPr>
          <p:spPr>
            <a:xfrm rot="16200000">
              <a:off x="2927123" y="2792019"/>
              <a:ext cx="879182" cy="5877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CK1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CK2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CK3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CK1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CK2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CK3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21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2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2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41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42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4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81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8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83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21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2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2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41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42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4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81A</a:t>
              </a: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8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47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8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0819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</Words>
  <Application>Microsoft Office PowerPoint</Application>
  <PresentationFormat>On-screen Show (4:3)</PresentationFormat>
  <Paragraphs>1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45</dc:creator>
  <cp:lastModifiedBy>OF45</cp:lastModifiedBy>
  <cp:revision>1</cp:revision>
  <dcterms:created xsi:type="dcterms:W3CDTF">2022-03-27T00:02:51Z</dcterms:created>
  <dcterms:modified xsi:type="dcterms:W3CDTF">2022-03-27T00:03:45Z</dcterms:modified>
</cp:coreProperties>
</file>